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03D380-A3D9-4EA7-9822-E929C86D65B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BB3C6E-3831-4D9F-900D-F981E886F2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441A4F-C355-4D7F-A99F-7A3322E16B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CB12B-E1FD-4A13-BD15-E4D4084EFA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42B744-9F6C-4806-9363-7E241543E9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A9386D-160B-4A1F-AAF4-565AF7468D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BA26F-282D-4BDA-BBC5-01854531F4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FB6EA-1DC2-4F42-8ACF-ED6458C2E6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C45DEE-F533-4BCF-BFA2-02B9626FAD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F9AB4-F21F-41E7-92EB-46127ADB31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7EB57B-4836-4194-8810-C8A820C999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534289-E641-42BD-AD2E-73B7D92C34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42A468-7ACA-4F83-802F-4FB203EB507C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3470" t="10604" r="1932" b="5103"/>
          <a:stretch/>
        </p:blipFill>
        <p:spPr>
          <a:xfrm>
            <a:off x="179280" y="404640"/>
            <a:ext cx="8785440" cy="54007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755640" y="6323040"/>
            <a:ext cx="698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ig. S3 Genes involved in plant circadian rhythm. Gene with in the red box were discovered in this stud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" descr=""/>
          <p:cNvPicPr/>
          <p:nvPr/>
        </p:nvPicPr>
        <p:blipFill>
          <a:blip r:embed="rId1"/>
          <a:srcRect l="2533" t="3125" r="1458" b="3515"/>
          <a:stretch/>
        </p:blipFill>
        <p:spPr>
          <a:xfrm>
            <a:off x="106200" y="333360"/>
            <a:ext cx="8929800" cy="6062760"/>
          </a:xfrm>
          <a:prstGeom prst="rect">
            <a:avLst/>
          </a:prstGeom>
          <a:ln w="0">
            <a:noFill/>
          </a:ln>
        </p:spPr>
      </p:pic>
      <p:sp>
        <p:nvSpPr>
          <p:cNvPr id="62" name=""/>
          <p:cNvSpPr/>
          <p:nvPr/>
        </p:nvSpPr>
        <p:spPr>
          <a:xfrm>
            <a:off x="1692360" y="6165720"/>
            <a:ext cx="374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Fig. S12 Flavonoid biosynthesi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rcRect l="1053" t="9512" r="4312" b="4808"/>
          <a:stretch/>
        </p:blipFill>
        <p:spPr>
          <a:xfrm>
            <a:off x="1763640" y="260280"/>
            <a:ext cx="5838840" cy="590400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900000" y="6381720"/>
            <a:ext cx="734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ig. S4 Genes involved in intra-cellular transportation. Genes in the red box were discovered in this stud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rcRect l="808" t="10227" r="2248" b="3849"/>
          <a:stretch/>
        </p:blipFill>
        <p:spPr>
          <a:xfrm>
            <a:off x="361800" y="264960"/>
            <a:ext cx="7955280" cy="572292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1476360" y="6165720"/>
            <a:ext cx="6264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Fig. S5 Plant spliceosome related genes. Genes in the red box were discovered in this stud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rcRect l="2754" t="23580" r="1820" b="7178"/>
          <a:stretch/>
        </p:blipFill>
        <p:spPr>
          <a:xfrm>
            <a:off x="395280" y="765000"/>
            <a:ext cx="8317080" cy="375768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1908000" y="5229360"/>
            <a:ext cx="482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ig. S6 Genes involved in eukaryotes basal transcription factor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"/>
          <p:cNvGrpSpPr/>
          <p:nvPr/>
        </p:nvGrpSpPr>
        <p:grpSpPr>
          <a:xfrm>
            <a:off x="393840" y="333360"/>
            <a:ext cx="8425800" cy="5486400"/>
            <a:chOff x="393840" y="333360"/>
            <a:chExt cx="8425800" cy="5486400"/>
          </a:xfrm>
        </p:grpSpPr>
        <p:pic>
          <p:nvPicPr>
            <p:cNvPr id="50" name="" descr=""/>
            <p:cNvPicPr/>
            <p:nvPr/>
          </p:nvPicPr>
          <p:blipFill>
            <a:blip r:embed="rId1"/>
            <a:srcRect l="1717" t="8504" r="68339" b="3990"/>
            <a:stretch/>
          </p:blipFill>
          <p:spPr>
            <a:xfrm>
              <a:off x="393840" y="333360"/>
              <a:ext cx="2410920" cy="54864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1" name="" descr=""/>
            <p:cNvPicPr/>
            <p:nvPr/>
          </p:nvPicPr>
          <p:blipFill>
            <a:blip r:embed="rId2"/>
            <a:srcRect l="31230" t="17418" r="1717" b="3990"/>
            <a:stretch/>
          </p:blipFill>
          <p:spPr>
            <a:xfrm>
              <a:off x="2812680" y="334800"/>
              <a:ext cx="6006960" cy="54817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sp>
        <p:nvSpPr>
          <p:cNvPr id="52" name=""/>
          <p:cNvSpPr/>
          <p:nvPr/>
        </p:nvSpPr>
        <p:spPr>
          <a:xfrm>
            <a:off x="1909800" y="6093000"/>
            <a:ext cx="3382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ig. S7 Genes encoding ribosomal protein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rcRect l="2236" t="13338" r="1971" b="5377"/>
          <a:stretch/>
        </p:blipFill>
        <p:spPr>
          <a:xfrm>
            <a:off x="250920" y="476280"/>
            <a:ext cx="8713800" cy="504036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971640" y="5877000"/>
            <a:ext cx="309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Fig. S8 Brassinosteroid biosynthesis gen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" descr=""/>
          <p:cNvPicPr/>
          <p:nvPr/>
        </p:nvPicPr>
        <p:blipFill>
          <a:blip r:embed="rId1"/>
          <a:srcRect l="47834" t="16173" r="1634" b="12822"/>
          <a:stretch/>
        </p:blipFill>
        <p:spPr>
          <a:xfrm>
            <a:off x="1042920" y="476280"/>
            <a:ext cx="6842160" cy="5200560"/>
          </a:xfrm>
          <a:prstGeom prst="rect">
            <a:avLst/>
          </a:prstGeom>
          <a:ln w="0">
            <a:noFill/>
          </a:ln>
        </p:spPr>
      </p:pic>
      <p:sp>
        <p:nvSpPr>
          <p:cNvPr id="56" name=""/>
          <p:cNvSpPr/>
          <p:nvPr/>
        </p:nvSpPr>
        <p:spPr>
          <a:xfrm>
            <a:off x="2554200" y="6021360"/>
            <a:ext cx="424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ig. S9 Light harvesting chlorophyll protein complex gen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" descr=""/>
          <p:cNvPicPr/>
          <p:nvPr/>
        </p:nvPicPr>
        <p:blipFill>
          <a:blip r:embed="rId1"/>
          <a:srcRect l="931" t="5234" r="1982" b="4468"/>
          <a:stretch/>
        </p:blipFill>
        <p:spPr>
          <a:xfrm>
            <a:off x="179280" y="404640"/>
            <a:ext cx="8785440" cy="619308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>
            <a:off x="1258920" y="6442200"/>
            <a:ext cx="223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S10 TCA cycl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"/>
          <p:cNvSpPr/>
          <p:nvPr/>
        </p:nvSpPr>
        <p:spPr>
          <a:xfrm>
            <a:off x="3635280" y="5805360"/>
            <a:ext cx="338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Fig. S11 Phenylpropanoid biosynthe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" descr=""/>
          <p:cNvPicPr/>
          <p:nvPr/>
        </p:nvPicPr>
        <p:blipFill>
          <a:blip r:embed="rId1"/>
          <a:srcRect l="1558" t="8782" r="1744" b="5615"/>
          <a:stretch/>
        </p:blipFill>
        <p:spPr>
          <a:xfrm>
            <a:off x="34920" y="260280"/>
            <a:ext cx="9001080" cy="5076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9T16:23:07Z</dcterms:created>
  <dc:creator>tclsevers</dc:creator>
  <dc:description/>
  <dc:language>en-US</dc:language>
  <cp:lastModifiedBy>tclsevers</cp:lastModifiedBy>
  <dcterms:modified xsi:type="dcterms:W3CDTF">2013-01-29T16:23:17Z</dcterms:modified>
  <cp:revision>1</cp:revision>
  <dc:subject/>
  <dc:title>幻灯片 1</dc:title>
</cp:coreProperties>
</file>